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3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793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50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510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28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89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199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1983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357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623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396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964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149E5F-01D7-4A66-90EF-DB2263D0E27D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81433-938A-4ADE-AB43-413D8F787D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823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55272" y="86455"/>
            <a:ext cx="630940" cy="4728733"/>
            <a:chOff x="230472" y="296324"/>
            <a:chExt cx="413103" cy="309610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t="13177" b="12945"/>
            <a:stretch/>
          </p:blipFill>
          <p:spPr>
            <a:xfrm rot="5400000">
              <a:off x="-1045624" y="1703226"/>
              <a:ext cx="2965295" cy="413103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259363" y="296324"/>
              <a:ext cx="356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A1</a:t>
              </a:r>
              <a:endParaRPr lang="en-US" sz="1050" dirty="0"/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653109" y="86455"/>
            <a:ext cx="720076" cy="4697277"/>
            <a:chOff x="717255" y="296324"/>
            <a:chExt cx="471464" cy="307550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5400000">
              <a:off x="-491932" y="1691179"/>
              <a:ext cx="2889837" cy="471464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757852" y="296324"/>
              <a:ext cx="356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A2</a:t>
              </a:r>
              <a:endParaRPr lang="en-US" sz="1050" dirty="0"/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1320489" y="75418"/>
            <a:ext cx="636290" cy="4673120"/>
            <a:chOff x="1229314" y="296324"/>
            <a:chExt cx="416606" cy="3059690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 rot="5400000">
              <a:off x="21834" y="1731929"/>
              <a:ext cx="2831565" cy="416606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1256340" y="296324"/>
              <a:ext cx="356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A3</a:t>
              </a:r>
              <a:endParaRPr lang="en-US" sz="1050" dirty="0"/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1970255" y="86455"/>
            <a:ext cx="595724" cy="4673121"/>
            <a:chOff x="1787792" y="296324"/>
            <a:chExt cx="390046" cy="3059693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 rot="5400000">
              <a:off x="545803" y="1723982"/>
              <a:ext cx="2874024" cy="390046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787792" y="296324"/>
              <a:ext cx="356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A4</a:t>
              </a:r>
              <a:endParaRPr lang="en-US" sz="1050" dirty="0"/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2675336" y="77057"/>
            <a:ext cx="624391" cy="4705545"/>
            <a:chOff x="2334280" y="296324"/>
            <a:chExt cx="408815" cy="3080919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 rot="5400000">
              <a:off x="1121465" y="1755612"/>
              <a:ext cx="2834446" cy="408815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2342711" y="296324"/>
              <a:ext cx="356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A5</a:t>
              </a:r>
              <a:endParaRPr lang="en-US" sz="1050" dirty="0"/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3400231" y="86455"/>
            <a:ext cx="647945" cy="4729802"/>
            <a:chOff x="2832495" y="296323"/>
            <a:chExt cx="566978" cy="4138770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rot="5400000">
              <a:off x="1203008" y="2238629"/>
              <a:ext cx="3825951" cy="566978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2860490" y="296323"/>
              <a:ext cx="47660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A6</a:t>
              </a:r>
              <a:endParaRPr lang="en-US" sz="1050" dirty="0"/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4048975" y="96313"/>
            <a:ext cx="607555" cy="4720736"/>
            <a:chOff x="3326551" y="296324"/>
            <a:chExt cx="397792" cy="3090864"/>
          </a:xfrm>
        </p:grpSpPr>
        <p:sp>
          <p:nvSpPr>
            <p:cNvPr id="21" name="TextBox 20"/>
            <p:cNvSpPr txBox="1"/>
            <p:nvPr/>
          </p:nvSpPr>
          <p:spPr>
            <a:xfrm>
              <a:off x="3347139" y="296324"/>
              <a:ext cx="356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A7</a:t>
              </a:r>
              <a:endParaRPr lang="en-US" sz="1050" dirty="0"/>
            </a:p>
          </p:txBody>
        </p:sp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 rot="5400000">
              <a:off x="2094077" y="1756923"/>
              <a:ext cx="2862739" cy="397792"/>
            </a:xfrm>
            <a:prstGeom prst="rect">
              <a:avLst/>
            </a:prstGeom>
          </p:spPr>
        </p:pic>
      </p:grpSp>
      <p:grpSp>
        <p:nvGrpSpPr>
          <p:cNvPr id="27" name="Group 26"/>
          <p:cNvGrpSpPr/>
          <p:nvPr/>
        </p:nvGrpSpPr>
        <p:grpSpPr>
          <a:xfrm>
            <a:off x="4673889" y="86457"/>
            <a:ext cx="650309" cy="4724762"/>
            <a:chOff x="3833787" y="293685"/>
            <a:chExt cx="425785" cy="3093503"/>
          </a:xfrm>
        </p:grpSpPr>
        <p:sp>
          <p:nvSpPr>
            <p:cNvPr id="22" name="TextBox 21"/>
            <p:cNvSpPr txBox="1"/>
            <p:nvPr/>
          </p:nvSpPr>
          <p:spPr>
            <a:xfrm>
              <a:off x="3833787" y="293685"/>
              <a:ext cx="356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A8</a:t>
              </a:r>
              <a:endParaRPr lang="en-US" sz="1050" dirty="0"/>
            </a:p>
          </p:txBody>
        </p:sp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rot="5400000">
              <a:off x="2625279" y="1752895"/>
              <a:ext cx="2857465" cy="411121"/>
            </a:xfrm>
            <a:prstGeom prst="rect">
              <a:avLst/>
            </a:prstGeom>
          </p:spPr>
        </p:pic>
      </p:grpSp>
      <p:grpSp>
        <p:nvGrpSpPr>
          <p:cNvPr id="29" name="Group 28"/>
          <p:cNvGrpSpPr/>
          <p:nvPr/>
        </p:nvGrpSpPr>
        <p:grpSpPr>
          <a:xfrm>
            <a:off x="5357198" y="96313"/>
            <a:ext cx="641570" cy="4667301"/>
            <a:chOff x="4346573" y="293685"/>
            <a:chExt cx="420063" cy="3055880"/>
          </a:xfrm>
        </p:grpSpPr>
        <p:sp>
          <p:nvSpPr>
            <p:cNvPr id="23" name="TextBox 22"/>
            <p:cNvSpPr txBox="1"/>
            <p:nvPr/>
          </p:nvSpPr>
          <p:spPr>
            <a:xfrm>
              <a:off x="4365239" y="293685"/>
              <a:ext cx="356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A9</a:t>
              </a:r>
              <a:endParaRPr lang="en-US" sz="1050" dirty="0"/>
            </a:p>
          </p:txBody>
        </p:sp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 rot="5400000">
              <a:off x="3133433" y="1716361"/>
              <a:ext cx="2846344" cy="420063"/>
            </a:xfrm>
            <a:prstGeom prst="rect">
              <a:avLst/>
            </a:prstGeom>
          </p:spPr>
        </p:pic>
      </p:grpSp>
      <p:grpSp>
        <p:nvGrpSpPr>
          <p:cNvPr id="3" name="Group 2"/>
          <p:cNvGrpSpPr/>
          <p:nvPr/>
        </p:nvGrpSpPr>
        <p:grpSpPr>
          <a:xfrm>
            <a:off x="6027672" y="86455"/>
            <a:ext cx="642680" cy="4677158"/>
            <a:chOff x="4869955" y="293685"/>
            <a:chExt cx="420790" cy="3062332"/>
          </a:xfrm>
        </p:grpSpPr>
        <p:sp>
          <p:nvSpPr>
            <p:cNvPr id="30" name="TextBox 29"/>
            <p:cNvSpPr txBox="1"/>
            <p:nvPr/>
          </p:nvSpPr>
          <p:spPr>
            <a:xfrm>
              <a:off x="4907512" y="293685"/>
              <a:ext cx="356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B1</a:t>
              </a:r>
              <a:endParaRPr lang="en-US" sz="1050" dirty="0"/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 rot="5400000">
              <a:off x="3656789" y="1722062"/>
              <a:ext cx="2847121" cy="420790"/>
            </a:xfrm>
            <a:prstGeom prst="rect">
              <a:avLst/>
            </a:prstGeom>
          </p:spPr>
        </p:pic>
      </p:grpSp>
      <p:grpSp>
        <p:nvGrpSpPr>
          <p:cNvPr id="41" name="Group 40"/>
          <p:cNvGrpSpPr/>
          <p:nvPr/>
        </p:nvGrpSpPr>
        <p:grpSpPr>
          <a:xfrm>
            <a:off x="6720100" y="75418"/>
            <a:ext cx="652328" cy="4734624"/>
            <a:chOff x="5367444" y="293685"/>
            <a:chExt cx="427107" cy="3099957"/>
          </a:xfrm>
        </p:grpSpPr>
        <p:sp>
          <p:nvSpPr>
            <p:cNvPr id="31" name="TextBox 30"/>
            <p:cNvSpPr txBox="1"/>
            <p:nvPr/>
          </p:nvSpPr>
          <p:spPr>
            <a:xfrm>
              <a:off x="5372978" y="293685"/>
              <a:ext cx="3566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B2</a:t>
              </a:r>
            </a:p>
          </p:txBody>
        </p:sp>
        <p:pic>
          <p:nvPicPr>
            <p:cNvPr id="39" name="Picture 38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 rot="5400000">
              <a:off x="4146402" y="1745493"/>
              <a:ext cx="2869191" cy="427107"/>
            </a:xfrm>
            <a:prstGeom prst="rect">
              <a:avLst/>
            </a:prstGeom>
          </p:spPr>
        </p:pic>
      </p:grpSp>
      <p:grpSp>
        <p:nvGrpSpPr>
          <p:cNvPr id="42" name="Group 41"/>
          <p:cNvGrpSpPr/>
          <p:nvPr/>
        </p:nvGrpSpPr>
        <p:grpSpPr>
          <a:xfrm>
            <a:off x="7394081" y="75418"/>
            <a:ext cx="627790" cy="4730637"/>
            <a:chOff x="5838444" y="289838"/>
            <a:chExt cx="411041" cy="3097350"/>
          </a:xfrm>
        </p:grpSpPr>
        <p:sp>
          <p:nvSpPr>
            <p:cNvPr id="32" name="TextBox 31"/>
            <p:cNvSpPr txBox="1"/>
            <p:nvPr/>
          </p:nvSpPr>
          <p:spPr>
            <a:xfrm>
              <a:off x="5838444" y="289838"/>
              <a:ext cx="3566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B3</a:t>
              </a:r>
              <a:endParaRPr lang="en-US" sz="1050" dirty="0"/>
            </a:p>
          </p:txBody>
        </p:sp>
        <p:pic>
          <p:nvPicPr>
            <p:cNvPr id="40" name="Picture 39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 rot="5400000">
              <a:off x="4606891" y="1744595"/>
              <a:ext cx="2883969" cy="401218"/>
            </a:xfrm>
            <a:prstGeom prst="rect">
              <a:avLst/>
            </a:prstGeom>
          </p:spPr>
        </p:pic>
      </p:grpSp>
      <p:grpSp>
        <p:nvGrpSpPr>
          <p:cNvPr id="44" name="Group 43"/>
          <p:cNvGrpSpPr/>
          <p:nvPr/>
        </p:nvGrpSpPr>
        <p:grpSpPr>
          <a:xfrm>
            <a:off x="8074426" y="75418"/>
            <a:ext cx="630268" cy="4707184"/>
            <a:chOff x="6278681" y="289838"/>
            <a:chExt cx="412664" cy="3081995"/>
          </a:xfrm>
        </p:grpSpPr>
        <p:sp>
          <p:nvSpPr>
            <p:cNvPr id="33" name="TextBox 32"/>
            <p:cNvSpPr txBox="1"/>
            <p:nvPr/>
          </p:nvSpPr>
          <p:spPr>
            <a:xfrm>
              <a:off x="6303910" y="289838"/>
              <a:ext cx="3566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B4</a:t>
              </a:r>
            </a:p>
          </p:txBody>
        </p:sp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 rot="5400000">
              <a:off x="5061322" y="1741810"/>
              <a:ext cx="2847382" cy="412664"/>
            </a:xfrm>
            <a:prstGeom prst="rect">
              <a:avLst/>
            </a:prstGeom>
          </p:spPr>
        </p:pic>
      </p:grpSp>
      <p:grpSp>
        <p:nvGrpSpPr>
          <p:cNvPr id="46" name="Group 45"/>
          <p:cNvGrpSpPr/>
          <p:nvPr/>
        </p:nvGrpSpPr>
        <p:grpSpPr>
          <a:xfrm>
            <a:off x="8726951" y="92332"/>
            <a:ext cx="640363" cy="4718887"/>
            <a:chOff x="6744090" y="297532"/>
            <a:chExt cx="419273" cy="3089656"/>
          </a:xfrm>
        </p:grpSpPr>
        <p:sp>
          <p:nvSpPr>
            <p:cNvPr id="34" name="TextBox 33"/>
            <p:cNvSpPr txBox="1"/>
            <p:nvPr/>
          </p:nvSpPr>
          <p:spPr>
            <a:xfrm>
              <a:off x="6763843" y="297532"/>
              <a:ext cx="3566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B5</a:t>
              </a:r>
            </a:p>
          </p:txBody>
        </p:sp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 rot="5400000">
              <a:off x="5522357" y="1746182"/>
              <a:ext cx="2862739" cy="419273"/>
            </a:xfrm>
            <a:prstGeom prst="rect">
              <a:avLst/>
            </a:prstGeom>
          </p:spPr>
        </p:pic>
      </p:grpSp>
      <p:grpSp>
        <p:nvGrpSpPr>
          <p:cNvPr id="48" name="Group 47"/>
          <p:cNvGrpSpPr/>
          <p:nvPr/>
        </p:nvGrpSpPr>
        <p:grpSpPr>
          <a:xfrm>
            <a:off x="9424273" y="86455"/>
            <a:ext cx="584200" cy="4750554"/>
            <a:chOff x="7297758" y="289838"/>
            <a:chExt cx="382500" cy="3110387"/>
          </a:xfrm>
        </p:grpSpPr>
        <p:sp>
          <p:nvSpPr>
            <p:cNvPr id="35" name="TextBox 34"/>
            <p:cNvSpPr txBox="1"/>
            <p:nvPr/>
          </p:nvSpPr>
          <p:spPr>
            <a:xfrm>
              <a:off x="7311649" y="289838"/>
              <a:ext cx="3566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B6</a:t>
              </a:r>
            </a:p>
          </p:txBody>
        </p:sp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 rot="5400000">
              <a:off x="6071710" y="1791677"/>
              <a:ext cx="2834596" cy="382500"/>
            </a:xfrm>
            <a:prstGeom prst="rect">
              <a:avLst/>
            </a:prstGeom>
          </p:spPr>
        </p:pic>
      </p:grpSp>
      <p:grpSp>
        <p:nvGrpSpPr>
          <p:cNvPr id="50" name="Group 49"/>
          <p:cNvGrpSpPr/>
          <p:nvPr/>
        </p:nvGrpSpPr>
        <p:grpSpPr>
          <a:xfrm>
            <a:off x="10051684" y="75418"/>
            <a:ext cx="603656" cy="4718888"/>
            <a:chOff x="7804478" y="289838"/>
            <a:chExt cx="395239" cy="3089653"/>
          </a:xfrm>
        </p:grpSpPr>
        <p:sp>
          <p:nvSpPr>
            <p:cNvPr id="36" name="TextBox 35"/>
            <p:cNvSpPr txBox="1"/>
            <p:nvPr/>
          </p:nvSpPr>
          <p:spPr>
            <a:xfrm>
              <a:off x="7843101" y="289838"/>
              <a:ext cx="3566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B7</a:t>
              </a:r>
            </a:p>
          </p:txBody>
        </p:sp>
        <p:pic>
          <p:nvPicPr>
            <p:cNvPr id="49" name="Picture 48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 rot="5400000">
              <a:off x="6589879" y="1772535"/>
              <a:ext cx="2821555" cy="392357"/>
            </a:xfrm>
            <a:prstGeom prst="rect">
              <a:avLst/>
            </a:prstGeom>
          </p:spPr>
        </p:pic>
      </p:grpSp>
      <p:grpSp>
        <p:nvGrpSpPr>
          <p:cNvPr id="52" name="Group 51"/>
          <p:cNvGrpSpPr/>
          <p:nvPr/>
        </p:nvGrpSpPr>
        <p:grpSpPr>
          <a:xfrm>
            <a:off x="10699158" y="75595"/>
            <a:ext cx="587113" cy="4750377"/>
            <a:chOff x="8360966" y="304018"/>
            <a:chExt cx="384408" cy="3110275"/>
          </a:xfrm>
        </p:grpSpPr>
        <p:sp>
          <p:nvSpPr>
            <p:cNvPr id="37" name="TextBox 36"/>
            <p:cNvSpPr txBox="1"/>
            <p:nvPr/>
          </p:nvSpPr>
          <p:spPr>
            <a:xfrm>
              <a:off x="8388758" y="304018"/>
              <a:ext cx="3566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B8</a:t>
              </a:r>
            </a:p>
          </p:txBody>
        </p:sp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 rot="5400000">
              <a:off x="7120745" y="1791670"/>
              <a:ext cx="2862844" cy="382401"/>
            </a:xfrm>
            <a:prstGeom prst="rect">
              <a:avLst/>
            </a:prstGeom>
          </p:spPr>
        </p:pic>
      </p:grpSp>
      <p:grpSp>
        <p:nvGrpSpPr>
          <p:cNvPr id="54" name="Group 53"/>
          <p:cNvGrpSpPr/>
          <p:nvPr/>
        </p:nvGrpSpPr>
        <p:grpSpPr>
          <a:xfrm>
            <a:off x="11372536" y="75590"/>
            <a:ext cx="621915" cy="4750382"/>
            <a:chOff x="8862210" y="304018"/>
            <a:chExt cx="407194" cy="3110276"/>
          </a:xfrm>
        </p:grpSpPr>
        <p:sp>
          <p:nvSpPr>
            <p:cNvPr id="38" name="TextBox 37"/>
            <p:cNvSpPr txBox="1"/>
            <p:nvPr/>
          </p:nvSpPr>
          <p:spPr>
            <a:xfrm>
              <a:off x="8904617" y="304018"/>
              <a:ext cx="356616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 smtClean="0"/>
                <a:t>B9</a:t>
              </a:r>
            </a:p>
          </p:txBody>
        </p:sp>
        <p:pic>
          <p:nvPicPr>
            <p:cNvPr id="53" name="Picture 52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 rot="5400000">
              <a:off x="7630363" y="1775253"/>
              <a:ext cx="2870888" cy="407194"/>
            </a:xfrm>
            <a:prstGeom prst="rect">
              <a:avLst/>
            </a:prstGeom>
          </p:spPr>
        </p:pic>
      </p:grpSp>
      <p:sp>
        <p:nvSpPr>
          <p:cNvPr id="56" name="TextBox 55"/>
          <p:cNvSpPr txBox="1"/>
          <p:nvPr/>
        </p:nvSpPr>
        <p:spPr>
          <a:xfrm>
            <a:off x="256478" y="5166360"/>
            <a:ext cx="1164187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4. </a:t>
            </a:r>
            <a:r>
              <a:rPr lang="en-US" dirty="0" smtClean="0"/>
              <a:t>Comparison of </a:t>
            </a:r>
            <a:r>
              <a:rPr lang="en-US" dirty="0"/>
              <a:t>g</a:t>
            </a:r>
            <a:r>
              <a:rPr lang="en-US" dirty="0" smtClean="0"/>
              <a:t>enetic maps generated using </a:t>
            </a:r>
            <a:r>
              <a:rPr lang="en-US" dirty="0" err="1" smtClean="0"/>
              <a:t>MSTmap</a:t>
            </a:r>
            <a:r>
              <a:rPr lang="en-US" dirty="0" smtClean="0"/>
              <a:t> (left-hand side) and </a:t>
            </a:r>
            <a:r>
              <a:rPr lang="en-US" dirty="0" smtClean="0"/>
              <a:t>MAPMAKER </a:t>
            </a:r>
            <a:r>
              <a:rPr lang="en-US" dirty="0" smtClean="0"/>
              <a:t>(right-hand side).  Nearly 65% of markers were reordered </a:t>
            </a:r>
            <a:r>
              <a:rPr lang="en-US" smtClean="0"/>
              <a:t>in </a:t>
            </a:r>
            <a:r>
              <a:rPr lang="en-US" smtClean="0"/>
              <a:t>MAPMAKER </a:t>
            </a:r>
            <a:r>
              <a:rPr lang="en-US" dirty="0" smtClean="0"/>
              <a:t>compared to </a:t>
            </a:r>
            <a:r>
              <a:rPr lang="en-US" dirty="0" err="1" smtClean="0"/>
              <a:t>MSTmap</a:t>
            </a:r>
            <a:r>
              <a:rPr lang="en-US" dirty="0" smtClean="0"/>
              <a:t> maps.  The markers that occupied a different relative position in the two maps are connected by a line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0806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70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 Qi</dc:creator>
  <cp:lastModifiedBy>Katrien M. Devos</cp:lastModifiedBy>
  <cp:revision>18</cp:revision>
  <dcterms:created xsi:type="dcterms:W3CDTF">2017-04-04T20:12:08Z</dcterms:created>
  <dcterms:modified xsi:type="dcterms:W3CDTF">2018-03-23T05:53:37Z</dcterms:modified>
</cp:coreProperties>
</file>